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4" r:id="rId2"/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547"/>
    <p:restoredTop sz="94692"/>
  </p:normalViewPr>
  <p:slideViewPr>
    <p:cSldViewPr snapToGrid="0">
      <p:cViewPr varScale="1">
        <p:scale>
          <a:sx n="82" d="100"/>
          <a:sy n="82" d="100"/>
        </p:scale>
        <p:origin x="184" y="18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4D69110-E639-46D4-2FB0-F5082E82FE1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B68F3AB7-6BFF-1773-CECB-D491BFDF9EB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AEB2273-8E65-0F27-AB08-9D49D35C53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DEBAB-16B0-8846-91CB-30C59FEC410E}" type="datetimeFigureOut">
              <a:rPr kumimoji="1" lang="zh-CN" altLang="en-US" smtClean="0"/>
              <a:t>2026/3/6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97CBA42-7849-A59E-950C-19677E18C3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71233F7-F476-A686-A6E1-24914B16CF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6B961D-CAE5-0D4A-840B-BEF2A841F1E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5147508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946605B-4FEF-8E1B-0C66-C488126BBA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ACB1711-006C-5ED6-D92C-D6DBDDCA185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2A18268-4AF3-5F89-DEE2-B44EB12B02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DEBAB-16B0-8846-91CB-30C59FEC410E}" type="datetimeFigureOut">
              <a:rPr kumimoji="1" lang="zh-CN" altLang="en-US" smtClean="0"/>
              <a:t>2026/3/6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DB484CD-7DE9-A1C9-364E-A8E2C5B3F5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3D1CFC3-6B68-811C-ABA4-6D4E9114E7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6B961D-CAE5-0D4A-840B-BEF2A841F1E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8551855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C6C33244-E214-D1CE-5A69-18CB368EC6B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9981B43-F04C-EF02-A8EE-D71157D5AE3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68119A3-736C-937B-7C29-90824FDB4F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DEBAB-16B0-8846-91CB-30C59FEC410E}" type="datetimeFigureOut">
              <a:rPr kumimoji="1" lang="zh-CN" altLang="en-US" smtClean="0"/>
              <a:t>2026/3/6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47A215C-774C-228B-CAD8-D9A5A8F00C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6DD77EC-03D6-6C50-3FB5-23BD1D9CB4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6B961D-CAE5-0D4A-840B-BEF2A841F1E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5321220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873EA2E-C71C-ED59-93CF-4B785EFF75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A8B9B4D-2523-E961-0A3F-06B991C2CFD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B9CEA05-A259-F063-5BFE-976E0A880F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DEBAB-16B0-8846-91CB-30C59FEC410E}" type="datetimeFigureOut">
              <a:rPr kumimoji="1" lang="zh-CN" altLang="en-US" smtClean="0"/>
              <a:t>2026/3/6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5A7E173-796C-D1B5-D73A-AA06A650C0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3899227-3AA7-A00B-F322-9634BD9DE6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6B961D-CAE5-0D4A-840B-BEF2A841F1E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3086074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CB3603D-F8C5-F71B-D010-DD9DA5ABB8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D18198C-7DEE-F55B-B98E-8456F07B65F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C223DFC-6E35-8DD7-7097-ECB92EC8B2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DEBAB-16B0-8846-91CB-30C59FEC410E}" type="datetimeFigureOut">
              <a:rPr kumimoji="1" lang="zh-CN" altLang="en-US" smtClean="0"/>
              <a:t>2026/3/6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08965A5-1B1C-F80A-D7E6-F8A8B48EE3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5A62341-BF1D-B9EC-6443-6F66113217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6B961D-CAE5-0D4A-840B-BEF2A841F1E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9955626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AE28610-F485-F1FC-A3D5-09C1FD51DD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0601F97-F6FF-71E5-64D3-5190B5C77FC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E792A0ED-B5BC-3E93-93FB-9A1B9DEB323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B3A66F0-0F5C-ABF8-1E16-964120EEC2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DEBAB-16B0-8846-91CB-30C59FEC410E}" type="datetimeFigureOut">
              <a:rPr kumimoji="1" lang="zh-CN" altLang="en-US" smtClean="0"/>
              <a:t>2026/3/6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FFF6FEF-3D7F-4B12-BE51-FA978A118D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F3E8BD9-350F-846B-E94C-466C61FE41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6B961D-CAE5-0D4A-840B-BEF2A841F1E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5916783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10D695F-406D-981F-1B3D-8334AFAC11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24F57BB-FE3D-4A5F-6E42-FCC4E405AA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E8C32F13-09CA-5847-E5B1-127B75F8463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F6252365-006F-6570-9DF3-4213B3198B1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98C98CB2-F61C-2E2A-5D6A-C78A5F5FD71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CE3F32F7-C354-A9E8-FEE5-4CC812583B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DEBAB-16B0-8846-91CB-30C59FEC410E}" type="datetimeFigureOut">
              <a:rPr kumimoji="1" lang="zh-CN" altLang="en-US" smtClean="0"/>
              <a:t>2026/3/6</a:t>
            </a:fld>
            <a:endParaRPr kumimoji="1"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03B19C07-4F92-7940-E6CA-051DCB45E4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A7184DEF-7C4B-B391-D3D0-3A4936B357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6B961D-CAE5-0D4A-840B-BEF2A841F1E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5429417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EB692F0-E6CA-A586-8CD6-E7C82C9570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AA117ACA-2465-379C-20F0-D345355AF1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DEBAB-16B0-8846-91CB-30C59FEC410E}" type="datetimeFigureOut">
              <a:rPr kumimoji="1" lang="zh-CN" altLang="en-US" smtClean="0"/>
              <a:t>2026/3/6</a:t>
            </a:fld>
            <a:endParaRPr kumimoji="1"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9F4EC85F-57AF-D4C6-A5CF-0D1053696A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2CCBB1E3-C109-07B8-144A-D85734101E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6B961D-CAE5-0D4A-840B-BEF2A841F1E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119069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CA9A1E3F-BE7A-E17D-A7BE-14E1D6CB71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DEBAB-16B0-8846-91CB-30C59FEC410E}" type="datetimeFigureOut">
              <a:rPr kumimoji="1" lang="zh-CN" altLang="en-US" smtClean="0"/>
              <a:t>2026/3/6</a:t>
            </a:fld>
            <a:endParaRPr kumimoji="1"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8B838FC9-3E97-2BD4-5951-6EBFC6232E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8DB9B56E-94D3-AAA7-9072-0834E0C3C0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6B961D-CAE5-0D4A-840B-BEF2A841F1E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9523008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49483BF-DE0D-79B2-0332-208D19FA5B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F1E14C7-B7DF-138F-DB1D-D8EFF506E9D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240A394-7BB2-5B06-90D9-05A8F8E2596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B5E5615-FCA1-CE80-F1FD-BE017951FA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DEBAB-16B0-8846-91CB-30C59FEC410E}" type="datetimeFigureOut">
              <a:rPr kumimoji="1" lang="zh-CN" altLang="en-US" smtClean="0"/>
              <a:t>2026/3/6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2E7CC61-16EA-3A69-8882-71FBC288F6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0B775BC-F61F-3256-51BF-EF9B757A59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6B961D-CAE5-0D4A-840B-BEF2A841F1E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3498870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60AD92F-65E6-2F5E-EF32-932FFDCECD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109D518D-276F-E0FF-8EEC-2B6824CF9D4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4EC42BD-BC05-58B0-8C7A-79DD1D877EE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29FABA0-6AEB-AD9B-83B3-4646F8172A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DEBAB-16B0-8846-91CB-30C59FEC410E}" type="datetimeFigureOut">
              <a:rPr kumimoji="1" lang="zh-CN" altLang="en-US" smtClean="0"/>
              <a:t>2026/3/6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12F44D4-FB40-7D7A-0390-4706D50044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886038D-E0BE-99AD-7CEB-FE059DBFEA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6B961D-CAE5-0D4A-840B-BEF2A841F1E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6322303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357DCFB8-00F2-20AB-F1EB-EAA1DE07A0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9FAA30B-CC5B-4000-06B3-F03FADBACC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65EC75F-0737-0A9A-A5FB-871CD419CED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ADEBAB-16B0-8846-91CB-30C59FEC410E}" type="datetimeFigureOut">
              <a:rPr kumimoji="1" lang="zh-CN" altLang="en-US" smtClean="0"/>
              <a:t>2026/3/6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5C8B27E-1E4A-0367-EEA9-4FBB72293EA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2DF3803-39FD-DBA0-0553-5CD4917CB1A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6B961D-CAE5-0D4A-840B-BEF2A841F1E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008656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FEF85793-F7D9-39F9-3F37-53557B51EEFE}"/>
              </a:ext>
            </a:extLst>
          </p:cNvPr>
          <p:cNvSpPr txBox="1"/>
          <p:nvPr/>
        </p:nvSpPr>
        <p:spPr>
          <a:xfrm>
            <a:off x="919463" y="371336"/>
            <a:ext cx="423483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kumimoji="1" lang="zh-CN" altLang="en-US" sz="2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kumimoji="1" lang="zh-CN" altLang="en-US" sz="2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substrate</a:t>
            </a:r>
            <a:r>
              <a:rPr kumimoji="1" lang="zh-CN" altLang="en-US" sz="2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oligos</a:t>
            </a:r>
            <a:endParaRPr kumimoji="1"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8" name="组合 17">
            <a:extLst>
              <a:ext uri="{FF2B5EF4-FFF2-40B4-BE49-F238E27FC236}">
                <a16:creationId xmlns:a16="http://schemas.microsoft.com/office/drawing/2014/main" id="{FACD44B1-418C-CA8F-5E4B-57C4E597B354}"/>
              </a:ext>
            </a:extLst>
          </p:cNvPr>
          <p:cNvGrpSpPr/>
          <p:nvPr/>
        </p:nvGrpSpPr>
        <p:grpSpPr>
          <a:xfrm>
            <a:off x="919463" y="1112923"/>
            <a:ext cx="10353073" cy="5372338"/>
            <a:chOff x="919463" y="1112923"/>
            <a:chExt cx="10353073" cy="5372338"/>
          </a:xfrm>
        </p:grpSpPr>
        <p:pic>
          <p:nvPicPr>
            <p:cNvPr id="16" name="图片 15" descr="图片包含 表格&#10;&#10;描述已自动生成">
              <a:extLst>
                <a:ext uri="{FF2B5EF4-FFF2-40B4-BE49-F238E27FC236}">
                  <a16:creationId xmlns:a16="http://schemas.microsoft.com/office/drawing/2014/main" id="{17212966-8914-589F-17E7-5EC26BE380F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919463" y="1112923"/>
              <a:ext cx="10353073" cy="5372338"/>
            </a:xfrm>
            <a:prstGeom prst="rect">
              <a:avLst/>
            </a:prstGeom>
          </p:spPr>
        </p:pic>
        <p:sp>
          <p:nvSpPr>
            <p:cNvPr id="17" name="矩形 16">
              <a:extLst>
                <a:ext uri="{FF2B5EF4-FFF2-40B4-BE49-F238E27FC236}">
                  <a16:creationId xmlns:a16="http://schemas.microsoft.com/office/drawing/2014/main" id="{B23316F1-8582-2E74-6EEA-6FFD38D04F4A}"/>
                </a:ext>
              </a:extLst>
            </p:cNvPr>
            <p:cNvSpPr/>
            <p:nvPr/>
          </p:nvSpPr>
          <p:spPr>
            <a:xfrm>
              <a:off x="919463" y="1199408"/>
              <a:ext cx="327446" cy="32063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4840890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18ED8989-95C9-C704-854F-3A8F60A77706}"/>
              </a:ext>
            </a:extLst>
          </p:cNvPr>
          <p:cNvSpPr txBox="1"/>
          <p:nvPr/>
        </p:nvSpPr>
        <p:spPr>
          <a:xfrm>
            <a:off x="952443" y="275953"/>
            <a:ext cx="1881441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2800" b="1" dirty="0">
                <a:latin typeface="Arial" panose="020B0604020202020204" pitchFamily="34" charset="0"/>
                <a:cs typeface="Arial" panose="020B0604020202020204" pitchFamily="34" charset="0"/>
              </a:rPr>
              <a:t>Fig. 3B</a:t>
            </a:r>
          </a:p>
          <a:p>
            <a:r>
              <a:rPr kumimoji="1" lang="en-US" altLang="zh-CN" sz="2800" b="1" dirty="0">
                <a:latin typeface="Arial" panose="020B0604020202020204" pitchFamily="34" charset="0"/>
                <a:cs typeface="Arial" panose="020B0604020202020204" pitchFamily="34" charset="0"/>
              </a:rPr>
              <a:t>Repeat 1</a:t>
            </a:r>
            <a:endParaRPr kumimoji="1" lang="zh-CN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607A8F06-C038-5A83-9C35-BA729D47CDAB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26848" y="1680649"/>
            <a:ext cx="6204611" cy="4978597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58F3B25A-6B11-C4FD-D818-D7590D9BE71E}"/>
              </a:ext>
            </a:extLst>
          </p:cNvPr>
          <p:cNvSpPr txBox="1"/>
          <p:nvPr/>
        </p:nvSpPr>
        <p:spPr>
          <a:xfrm rot="17974481">
            <a:off x="5143044" y="2240751"/>
            <a:ext cx="6189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D99FF4B8-862F-E9BD-9221-BD8BBEAC3630}"/>
              </a:ext>
            </a:extLst>
          </p:cNvPr>
          <p:cNvSpPr txBox="1"/>
          <p:nvPr/>
        </p:nvSpPr>
        <p:spPr>
          <a:xfrm rot="17974481">
            <a:off x="5477123" y="2240751"/>
            <a:ext cx="6189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BF3F0AB6-B7F7-26DE-4D18-898CE80CB7D0}"/>
              </a:ext>
            </a:extLst>
          </p:cNvPr>
          <p:cNvSpPr txBox="1"/>
          <p:nvPr/>
        </p:nvSpPr>
        <p:spPr>
          <a:xfrm rot="17974481">
            <a:off x="5839338" y="2240751"/>
            <a:ext cx="6189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3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5B236B9E-B1EB-606D-A616-34737EB8AF65}"/>
              </a:ext>
            </a:extLst>
          </p:cNvPr>
          <p:cNvSpPr txBox="1"/>
          <p:nvPr/>
        </p:nvSpPr>
        <p:spPr>
          <a:xfrm rot="17974481">
            <a:off x="6201554" y="2240751"/>
            <a:ext cx="6189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4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3754285E-23E2-5965-1202-4EA0E938EFA5}"/>
              </a:ext>
            </a:extLst>
          </p:cNvPr>
          <p:cNvSpPr txBox="1"/>
          <p:nvPr/>
        </p:nvSpPr>
        <p:spPr>
          <a:xfrm rot="17974481">
            <a:off x="3013835" y="2035792"/>
            <a:ext cx="15835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1-RNA ctrl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557A139F-D1AA-D98A-2A37-EB01DAF49765}"/>
              </a:ext>
            </a:extLst>
          </p:cNvPr>
          <p:cNvSpPr txBox="1"/>
          <p:nvPr/>
        </p:nvSpPr>
        <p:spPr>
          <a:xfrm rot="17974481">
            <a:off x="3379149" y="2050658"/>
            <a:ext cx="15493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2-RNA ctrl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76B8D530-BCFA-145E-8AE8-0039408994F2}"/>
              </a:ext>
            </a:extLst>
          </p:cNvPr>
          <p:cNvSpPr txBox="1"/>
          <p:nvPr/>
        </p:nvSpPr>
        <p:spPr>
          <a:xfrm rot="17974481">
            <a:off x="3704083" y="2023111"/>
            <a:ext cx="16127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3-RNA ctrl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D888BDBB-C0B7-E9B4-CE99-980BF02F990A}"/>
              </a:ext>
            </a:extLst>
          </p:cNvPr>
          <p:cNvSpPr txBox="1"/>
          <p:nvPr/>
        </p:nvSpPr>
        <p:spPr>
          <a:xfrm rot="17974481">
            <a:off x="4092280" y="2055570"/>
            <a:ext cx="15380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4-RNA ctrl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5" name="组合 24">
            <a:extLst>
              <a:ext uri="{FF2B5EF4-FFF2-40B4-BE49-F238E27FC236}">
                <a16:creationId xmlns:a16="http://schemas.microsoft.com/office/drawing/2014/main" id="{717DD4D2-3D3E-78A6-51DA-5800C38C6F11}"/>
              </a:ext>
            </a:extLst>
          </p:cNvPr>
          <p:cNvGrpSpPr/>
          <p:nvPr/>
        </p:nvGrpSpPr>
        <p:grpSpPr>
          <a:xfrm>
            <a:off x="1913206" y="2466981"/>
            <a:ext cx="920678" cy="3342966"/>
            <a:chOff x="1913206" y="2466981"/>
            <a:chExt cx="920678" cy="3342966"/>
          </a:xfrm>
        </p:grpSpPr>
        <p:sp>
          <p:nvSpPr>
            <p:cNvPr id="16" name="右大括号 15">
              <a:extLst>
                <a:ext uri="{FF2B5EF4-FFF2-40B4-BE49-F238E27FC236}">
                  <a16:creationId xmlns:a16="http://schemas.microsoft.com/office/drawing/2014/main" id="{0A9F8197-AD31-C1AC-484C-6823BF5620E2}"/>
                </a:ext>
              </a:extLst>
            </p:cNvPr>
            <p:cNvSpPr/>
            <p:nvPr/>
          </p:nvSpPr>
          <p:spPr>
            <a:xfrm flipH="1">
              <a:off x="2559561" y="2466981"/>
              <a:ext cx="267287" cy="1260962"/>
            </a:xfrm>
            <a:prstGeom prst="rightBrac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zh-CN" altLang="en-US"/>
            </a:p>
          </p:txBody>
        </p:sp>
        <p:cxnSp>
          <p:nvCxnSpPr>
            <p:cNvPr id="18" name="直线连接符 17">
              <a:extLst>
                <a:ext uri="{FF2B5EF4-FFF2-40B4-BE49-F238E27FC236}">
                  <a16:creationId xmlns:a16="http://schemas.microsoft.com/office/drawing/2014/main" id="{5FB0BF57-149C-D6FB-0597-EA071363877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587697" y="3981159"/>
              <a:ext cx="246187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右大括号 20">
              <a:extLst>
                <a:ext uri="{FF2B5EF4-FFF2-40B4-BE49-F238E27FC236}">
                  <a16:creationId xmlns:a16="http://schemas.microsoft.com/office/drawing/2014/main" id="{A3425164-3424-2D1F-78A2-23F8942700E9}"/>
                </a:ext>
              </a:extLst>
            </p:cNvPr>
            <p:cNvSpPr/>
            <p:nvPr/>
          </p:nvSpPr>
          <p:spPr>
            <a:xfrm flipH="1">
              <a:off x="2587697" y="4169946"/>
              <a:ext cx="207912" cy="1640001"/>
            </a:xfrm>
            <a:prstGeom prst="rightBrac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zh-CN" altLang="en-US"/>
            </a:p>
          </p:txBody>
        </p: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B6F831C3-5B20-D495-A743-05ABCEE9F37E}"/>
                </a:ext>
              </a:extLst>
            </p:cNvPr>
            <p:cNvSpPr txBox="1"/>
            <p:nvPr/>
          </p:nvSpPr>
          <p:spPr>
            <a:xfrm>
              <a:off x="2250487" y="2879892"/>
              <a:ext cx="49236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2400" dirty="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endParaRPr kumimoji="1" lang="zh-CN" altLang="en-US" sz="2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DCB34D09-6EEE-10EE-AE86-D24E02E1760D}"/>
                </a:ext>
              </a:extLst>
            </p:cNvPr>
            <p:cNvSpPr txBox="1"/>
            <p:nvPr/>
          </p:nvSpPr>
          <p:spPr>
            <a:xfrm>
              <a:off x="2218421" y="4759113"/>
              <a:ext cx="49236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24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kumimoji="1" lang="zh-CN" altLang="en-US" sz="2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72542F84-7C8A-3271-C7C3-31D2FECBC220}"/>
                </a:ext>
              </a:extLst>
            </p:cNvPr>
            <p:cNvSpPr txBox="1"/>
            <p:nvPr/>
          </p:nvSpPr>
          <p:spPr>
            <a:xfrm>
              <a:off x="1913206" y="3755686"/>
              <a:ext cx="7425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20nt</a:t>
              </a:r>
              <a:endParaRPr kumimoji="1"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6" name="文本框 25">
            <a:extLst>
              <a:ext uri="{FF2B5EF4-FFF2-40B4-BE49-F238E27FC236}">
                <a16:creationId xmlns:a16="http://schemas.microsoft.com/office/drawing/2014/main" id="{D8B832E5-1870-3C49-8533-3DE7EC51862C}"/>
              </a:ext>
            </a:extLst>
          </p:cNvPr>
          <p:cNvSpPr txBox="1"/>
          <p:nvPr/>
        </p:nvSpPr>
        <p:spPr>
          <a:xfrm rot="17974481">
            <a:off x="4716158" y="2455242"/>
            <a:ext cx="6189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6535076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54DE087D-D371-D7CB-227E-342BD7DB18D0}"/>
              </a:ext>
            </a:extLst>
          </p:cNvPr>
          <p:cNvSpPr txBox="1"/>
          <p:nvPr/>
        </p:nvSpPr>
        <p:spPr>
          <a:xfrm>
            <a:off x="1619856" y="364042"/>
            <a:ext cx="1881441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2800" b="1" dirty="0">
                <a:latin typeface="Arial" panose="020B0604020202020204" pitchFamily="34" charset="0"/>
                <a:cs typeface="Arial" panose="020B0604020202020204" pitchFamily="34" charset="0"/>
              </a:rPr>
              <a:t>Fig. 3B</a:t>
            </a:r>
          </a:p>
          <a:p>
            <a:r>
              <a:rPr kumimoji="1" lang="en-US" altLang="zh-CN" sz="2800" b="1" dirty="0">
                <a:latin typeface="Arial" panose="020B0604020202020204" pitchFamily="34" charset="0"/>
                <a:cs typeface="Arial" panose="020B0604020202020204" pitchFamily="34" charset="0"/>
              </a:rPr>
              <a:t>Repeat 2</a:t>
            </a:r>
            <a:endParaRPr kumimoji="1" lang="zh-CN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5" name="组合 24">
            <a:extLst>
              <a:ext uri="{FF2B5EF4-FFF2-40B4-BE49-F238E27FC236}">
                <a16:creationId xmlns:a16="http://schemas.microsoft.com/office/drawing/2014/main" id="{A66FF32F-8D43-512E-96B2-8264407A7068}"/>
              </a:ext>
            </a:extLst>
          </p:cNvPr>
          <p:cNvGrpSpPr/>
          <p:nvPr/>
        </p:nvGrpSpPr>
        <p:grpSpPr>
          <a:xfrm>
            <a:off x="1770232" y="2223944"/>
            <a:ext cx="920678" cy="3342966"/>
            <a:chOff x="1913206" y="2466981"/>
            <a:chExt cx="920678" cy="3342966"/>
          </a:xfrm>
        </p:grpSpPr>
        <p:sp>
          <p:nvSpPr>
            <p:cNvPr id="26" name="右大括号 25">
              <a:extLst>
                <a:ext uri="{FF2B5EF4-FFF2-40B4-BE49-F238E27FC236}">
                  <a16:creationId xmlns:a16="http://schemas.microsoft.com/office/drawing/2014/main" id="{82C65322-E223-F8BF-5A53-14DF80FE5A92}"/>
                </a:ext>
              </a:extLst>
            </p:cNvPr>
            <p:cNvSpPr/>
            <p:nvPr/>
          </p:nvSpPr>
          <p:spPr>
            <a:xfrm flipH="1">
              <a:off x="2559561" y="2466981"/>
              <a:ext cx="267287" cy="1260962"/>
            </a:xfrm>
            <a:prstGeom prst="rightBrac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zh-CN" altLang="en-US"/>
            </a:p>
          </p:txBody>
        </p:sp>
        <p:cxnSp>
          <p:nvCxnSpPr>
            <p:cNvPr id="27" name="直线连接符 26">
              <a:extLst>
                <a:ext uri="{FF2B5EF4-FFF2-40B4-BE49-F238E27FC236}">
                  <a16:creationId xmlns:a16="http://schemas.microsoft.com/office/drawing/2014/main" id="{E6AF8272-FE41-413C-1D43-A3DB2B756AA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587697" y="3981159"/>
              <a:ext cx="246187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右大括号 27">
              <a:extLst>
                <a:ext uri="{FF2B5EF4-FFF2-40B4-BE49-F238E27FC236}">
                  <a16:creationId xmlns:a16="http://schemas.microsoft.com/office/drawing/2014/main" id="{43C22D5A-ADBE-E85E-07C5-A071FFCB99E9}"/>
                </a:ext>
              </a:extLst>
            </p:cNvPr>
            <p:cNvSpPr/>
            <p:nvPr/>
          </p:nvSpPr>
          <p:spPr>
            <a:xfrm flipH="1">
              <a:off x="2587697" y="4169946"/>
              <a:ext cx="207912" cy="1640001"/>
            </a:xfrm>
            <a:prstGeom prst="rightBrac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zh-CN" altLang="en-US"/>
            </a:p>
          </p:txBody>
        </p: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3BF2ECA2-CEDC-6F4F-01CA-C68B11A3BDE2}"/>
                </a:ext>
              </a:extLst>
            </p:cNvPr>
            <p:cNvSpPr txBox="1"/>
            <p:nvPr/>
          </p:nvSpPr>
          <p:spPr>
            <a:xfrm>
              <a:off x="2250487" y="2879892"/>
              <a:ext cx="49236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2400" dirty="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endParaRPr kumimoji="1" lang="zh-CN" altLang="en-US" sz="2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24E1870C-A763-89EC-174D-315E4786F0C8}"/>
                </a:ext>
              </a:extLst>
            </p:cNvPr>
            <p:cNvSpPr txBox="1"/>
            <p:nvPr/>
          </p:nvSpPr>
          <p:spPr>
            <a:xfrm>
              <a:off x="2218421" y="4759113"/>
              <a:ext cx="49236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24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kumimoji="1" lang="zh-CN" altLang="en-US" sz="2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1E9E4B6B-A618-1889-4BE7-B40CCB9642B7}"/>
                </a:ext>
              </a:extLst>
            </p:cNvPr>
            <p:cNvSpPr txBox="1"/>
            <p:nvPr/>
          </p:nvSpPr>
          <p:spPr>
            <a:xfrm>
              <a:off x="1913206" y="3755686"/>
              <a:ext cx="7425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20nt</a:t>
              </a:r>
              <a:endParaRPr kumimoji="1"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24" name="图片 23">
            <a:extLst>
              <a:ext uri="{FF2B5EF4-FFF2-40B4-BE49-F238E27FC236}">
                <a16:creationId xmlns:a16="http://schemas.microsoft.com/office/drawing/2014/main" id="{F0FECA63-46EA-BEC2-5528-FE28DAFA86BE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90910" y="1704535"/>
            <a:ext cx="6164237" cy="4931389"/>
          </a:xfrm>
          <a:prstGeom prst="rect">
            <a:avLst/>
          </a:prstGeom>
        </p:spPr>
      </p:pic>
      <p:sp>
        <p:nvSpPr>
          <p:cNvPr id="15" name="文本框 14">
            <a:extLst>
              <a:ext uri="{FF2B5EF4-FFF2-40B4-BE49-F238E27FC236}">
                <a16:creationId xmlns:a16="http://schemas.microsoft.com/office/drawing/2014/main" id="{06A05DC5-CCAE-A91B-FADE-0D25CA96F042}"/>
              </a:ext>
            </a:extLst>
          </p:cNvPr>
          <p:cNvSpPr txBox="1"/>
          <p:nvPr/>
        </p:nvSpPr>
        <p:spPr>
          <a:xfrm rot="17974481">
            <a:off x="6006734" y="2418221"/>
            <a:ext cx="6189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3E580237-70C3-F3C1-E265-E6C564F702E6}"/>
              </a:ext>
            </a:extLst>
          </p:cNvPr>
          <p:cNvSpPr txBox="1"/>
          <p:nvPr/>
        </p:nvSpPr>
        <p:spPr>
          <a:xfrm rot="17974481">
            <a:off x="6340813" y="2417058"/>
            <a:ext cx="6189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F5C2C0E9-C886-E039-6D16-744657F024A2}"/>
              </a:ext>
            </a:extLst>
          </p:cNvPr>
          <p:cNvSpPr txBox="1"/>
          <p:nvPr/>
        </p:nvSpPr>
        <p:spPr>
          <a:xfrm rot="17974481">
            <a:off x="6703028" y="2417058"/>
            <a:ext cx="6189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3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0E0787C1-0C75-720E-DD4F-EF908FD4FAC6}"/>
              </a:ext>
            </a:extLst>
          </p:cNvPr>
          <p:cNvSpPr txBox="1"/>
          <p:nvPr/>
        </p:nvSpPr>
        <p:spPr>
          <a:xfrm rot="17974481">
            <a:off x="7065244" y="2417058"/>
            <a:ext cx="6189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4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F4EA5CA9-A9A8-0138-CFE7-3D91E76CF78A}"/>
              </a:ext>
            </a:extLst>
          </p:cNvPr>
          <p:cNvSpPr txBox="1"/>
          <p:nvPr/>
        </p:nvSpPr>
        <p:spPr>
          <a:xfrm rot="17974481">
            <a:off x="3843658" y="2326154"/>
            <a:ext cx="15835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1-RNA ctrl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2AA64DAF-1193-071B-0370-215858B97936}"/>
              </a:ext>
            </a:extLst>
          </p:cNvPr>
          <p:cNvSpPr txBox="1"/>
          <p:nvPr/>
        </p:nvSpPr>
        <p:spPr>
          <a:xfrm rot="17974481">
            <a:off x="4220261" y="2339857"/>
            <a:ext cx="15493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2-RNA ctrl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3C300DA9-AA0E-D34D-5A26-D2C129ECF693}"/>
              </a:ext>
            </a:extLst>
          </p:cNvPr>
          <p:cNvSpPr txBox="1"/>
          <p:nvPr/>
        </p:nvSpPr>
        <p:spPr>
          <a:xfrm rot="17974481">
            <a:off x="4577724" y="2312309"/>
            <a:ext cx="16127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3-RNA ctrl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72100B70-EA9B-479F-F6BC-237262827C66}"/>
              </a:ext>
            </a:extLst>
          </p:cNvPr>
          <p:cNvSpPr txBox="1"/>
          <p:nvPr/>
        </p:nvSpPr>
        <p:spPr>
          <a:xfrm rot="17974481">
            <a:off x="4981419" y="2344769"/>
            <a:ext cx="15380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4-RNA ctrl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5D83280F-96E5-AF93-AC5B-F1F82443C7B4}"/>
              </a:ext>
            </a:extLst>
          </p:cNvPr>
          <p:cNvSpPr txBox="1"/>
          <p:nvPr/>
        </p:nvSpPr>
        <p:spPr>
          <a:xfrm rot="17974481">
            <a:off x="5519837" y="2549168"/>
            <a:ext cx="10653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9669113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71582126-4C6D-A838-216C-A71E744E9A3C}"/>
              </a:ext>
            </a:extLst>
          </p:cNvPr>
          <p:cNvSpPr txBox="1"/>
          <p:nvPr/>
        </p:nvSpPr>
        <p:spPr>
          <a:xfrm>
            <a:off x="2067595" y="275102"/>
            <a:ext cx="1881441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2800" b="1" dirty="0">
                <a:latin typeface="Arial" panose="020B0604020202020204" pitchFamily="34" charset="0"/>
                <a:cs typeface="Arial" panose="020B0604020202020204" pitchFamily="34" charset="0"/>
              </a:rPr>
              <a:t>Fig. 3B</a:t>
            </a:r>
          </a:p>
          <a:p>
            <a:r>
              <a:rPr kumimoji="1" lang="en-US" altLang="zh-CN" sz="2800" b="1" dirty="0">
                <a:latin typeface="Arial" panose="020B0604020202020204" pitchFamily="34" charset="0"/>
                <a:cs typeface="Arial" panose="020B0604020202020204" pitchFamily="34" charset="0"/>
              </a:rPr>
              <a:t>Repeat 3</a:t>
            </a:r>
            <a:endParaRPr kumimoji="1" lang="zh-CN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图片 11" descr="图片包含 照片, 空气, 灯光, 桌子&#10;&#10;描述已自动生成">
            <a:extLst>
              <a:ext uri="{FF2B5EF4-FFF2-40B4-BE49-F238E27FC236}">
                <a16:creationId xmlns:a16="http://schemas.microsoft.com/office/drawing/2014/main" id="{821691F7-FBA5-1F8B-0D73-709C24844EFD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53408" y="1243081"/>
            <a:ext cx="6378840" cy="5102694"/>
          </a:xfrm>
          <a:prstGeom prst="rect">
            <a:avLst/>
          </a:prstGeom>
        </p:spPr>
      </p:pic>
      <p:grpSp>
        <p:nvGrpSpPr>
          <p:cNvPr id="13" name="组合 12">
            <a:extLst>
              <a:ext uri="{FF2B5EF4-FFF2-40B4-BE49-F238E27FC236}">
                <a16:creationId xmlns:a16="http://schemas.microsoft.com/office/drawing/2014/main" id="{F4E03C3F-D4AE-F94C-AAFB-814EFC759B52}"/>
              </a:ext>
            </a:extLst>
          </p:cNvPr>
          <p:cNvGrpSpPr/>
          <p:nvPr/>
        </p:nvGrpSpPr>
        <p:grpSpPr>
          <a:xfrm>
            <a:off x="2152358" y="2199692"/>
            <a:ext cx="920678" cy="3342966"/>
            <a:chOff x="1913206" y="2466981"/>
            <a:chExt cx="920678" cy="3342966"/>
          </a:xfrm>
        </p:grpSpPr>
        <p:sp>
          <p:nvSpPr>
            <p:cNvPr id="14" name="右大括号 13">
              <a:extLst>
                <a:ext uri="{FF2B5EF4-FFF2-40B4-BE49-F238E27FC236}">
                  <a16:creationId xmlns:a16="http://schemas.microsoft.com/office/drawing/2014/main" id="{9F64D68C-ECF8-4C6F-B881-E19AFE4E7FD0}"/>
                </a:ext>
              </a:extLst>
            </p:cNvPr>
            <p:cNvSpPr/>
            <p:nvPr/>
          </p:nvSpPr>
          <p:spPr>
            <a:xfrm flipH="1">
              <a:off x="2559561" y="2466981"/>
              <a:ext cx="267287" cy="1260962"/>
            </a:xfrm>
            <a:prstGeom prst="rightBrac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zh-CN" altLang="en-US"/>
            </a:p>
          </p:txBody>
        </p:sp>
        <p:cxnSp>
          <p:nvCxnSpPr>
            <p:cNvPr id="15" name="直线连接符 14">
              <a:extLst>
                <a:ext uri="{FF2B5EF4-FFF2-40B4-BE49-F238E27FC236}">
                  <a16:creationId xmlns:a16="http://schemas.microsoft.com/office/drawing/2014/main" id="{4937CF0A-3119-ECE9-C59F-286348BBC37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587697" y="3981159"/>
              <a:ext cx="246187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右大括号 15">
              <a:extLst>
                <a:ext uri="{FF2B5EF4-FFF2-40B4-BE49-F238E27FC236}">
                  <a16:creationId xmlns:a16="http://schemas.microsoft.com/office/drawing/2014/main" id="{E463D2F5-2A09-8AB9-F866-0E2D47FD2BD1}"/>
                </a:ext>
              </a:extLst>
            </p:cNvPr>
            <p:cNvSpPr/>
            <p:nvPr/>
          </p:nvSpPr>
          <p:spPr>
            <a:xfrm flipH="1">
              <a:off x="2587697" y="4169946"/>
              <a:ext cx="207912" cy="1640001"/>
            </a:xfrm>
            <a:prstGeom prst="rightBrac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zh-CN" altLang="en-US"/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23A3BC3F-8C46-26C8-2035-3B203866C859}"/>
                </a:ext>
              </a:extLst>
            </p:cNvPr>
            <p:cNvSpPr txBox="1"/>
            <p:nvPr/>
          </p:nvSpPr>
          <p:spPr>
            <a:xfrm>
              <a:off x="2250487" y="2879892"/>
              <a:ext cx="49236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2400" dirty="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endParaRPr kumimoji="1" lang="zh-CN" altLang="en-US" sz="2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CB89144F-826B-43AC-6EC0-D965757337A4}"/>
                </a:ext>
              </a:extLst>
            </p:cNvPr>
            <p:cNvSpPr txBox="1"/>
            <p:nvPr/>
          </p:nvSpPr>
          <p:spPr>
            <a:xfrm>
              <a:off x="2218421" y="4759113"/>
              <a:ext cx="49236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24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kumimoji="1" lang="zh-CN" altLang="en-US" sz="2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4D12D23C-1150-2C1E-094C-A649BC131D76}"/>
                </a:ext>
              </a:extLst>
            </p:cNvPr>
            <p:cNvSpPr txBox="1"/>
            <p:nvPr/>
          </p:nvSpPr>
          <p:spPr>
            <a:xfrm>
              <a:off x="1913206" y="3755686"/>
              <a:ext cx="7425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20nt</a:t>
              </a:r>
              <a:endParaRPr kumimoji="1"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" name="文本框 2">
            <a:extLst>
              <a:ext uri="{FF2B5EF4-FFF2-40B4-BE49-F238E27FC236}">
                <a16:creationId xmlns:a16="http://schemas.microsoft.com/office/drawing/2014/main" id="{5472570C-9231-CB3A-865F-5AE6773DA692}"/>
              </a:ext>
            </a:extLst>
          </p:cNvPr>
          <p:cNvSpPr txBox="1"/>
          <p:nvPr/>
        </p:nvSpPr>
        <p:spPr>
          <a:xfrm rot="17974481">
            <a:off x="5129273" y="2151077"/>
            <a:ext cx="6189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8214A194-A6D8-4818-72C4-5978DB330A57}"/>
              </a:ext>
            </a:extLst>
          </p:cNvPr>
          <p:cNvSpPr txBox="1"/>
          <p:nvPr/>
        </p:nvSpPr>
        <p:spPr>
          <a:xfrm rot="17974481">
            <a:off x="5484721" y="2151078"/>
            <a:ext cx="6189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94A6B054-F1D6-6A59-D0CF-5E8F0EC89241}"/>
              </a:ext>
            </a:extLst>
          </p:cNvPr>
          <p:cNvSpPr txBox="1"/>
          <p:nvPr/>
        </p:nvSpPr>
        <p:spPr>
          <a:xfrm rot="17974481">
            <a:off x="5800230" y="2151079"/>
            <a:ext cx="6189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3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6CED3334-E1F1-41FC-0560-87825477D31B}"/>
              </a:ext>
            </a:extLst>
          </p:cNvPr>
          <p:cNvSpPr txBox="1"/>
          <p:nvPr/>
        </p:nvSpPr>
        <p:spPr>
          <a:xfrm rot="17974481">
            <a:off x="6180886" y="2151079"/>
            <a:ext cx="5477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4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8B6BA4F5-9BCC-9BBA-2856-54134875CA98}"/>
              </a:ext>
            </a:extLst>
          </p:cNvPr>
          <p:cNvSpPr txBox="1"/>
          <p:nvPr/>
        </p:nvSpPr>
        <p:spPr>
          <a:xfrm rot="17974481">
            <a:off x="4668677" y="1973938"/>
            <a:ext cx="10653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7796162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E2F08870-6E1F-BD73-86CD-5105834B6CEC}"/>
              </a:ext>
            </a:extLst>
          </p:cNvPr>
          <p:cNvSpPr txBox="1"/>
          <p:nvPr/>
        </p:nvSpPr>
        <p:spPr>
          <a:xfrm>
            <a:off x="1998671" y="226332"/>
            <a:ext cx="1881441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2800" b="1" dirty="0">
                <a:latin typeface="Arial" panose="020B0604020202020204" pitchFamily="34" charset="0"/>
                <a:cs typeface="Arial" panose="020B0604020202020204" pitchFamily="34" charset="0"/>
              </a:rPr>
              <a:t>Fig. 3C</a:t>
            </a:r>
          </a:p>
          <a:p>
            <a:r>
              <a:rPr kumimoji="1" lang="en-US" altLang="zh-CN" sz="2800" b="1" dirty="0">
                <a:latin typeface="Arial" panose="020B0604020202020204" pitchFamily="34" charset="0"/>
                <a:cs typeface="Arial" panose="020B0604020202020204" pitchFamily="34" charset="0"/>
              </a:rPr>
              <a:t>Repeat 1</a:t>
            </a:r>
            <a:endParaRPr kumimoji="1" lang="zh-CN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图片 11">
            <a:extLst>
              <a:ext uri="{FF2B5EF4-FFF2-40B4-BE49-F238E27FC236}">
                <a16:creationId xmlns:a16="http://schemas.microsoft.com/office/drawing/2014/main" id="{D604012C-905C-C6FA-1805-57E312E3D2AF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42767" y="1397831"/>
            <a:ext cx="6306466" cy="5045172"/>
          </a:xfrm>
          <a:prstGeom prst="rect">
            <a:avLst/>
          </a:prstGeom>
        </p:spPr>
      </p:pic>
      <p:sp>
        <p:nvSpPr>
          <p:cNvPr id="14" name="文本框 13">
            <a:extLst>
              <a:ext uri="{FF2B5EF4-FFF2-40B4-BE49-F238E27FC236}">
                <a16:creationId xmlns:a16="http://schemas.microsoft.com/office/drawing/2014/main" id="{9718F6CA-6AF7-97F6-7256-AC25A16592FD}"/>
              </a:ext>
            </a:extLst>
          </p:cNvPr>
          <p:cNvSpPr txBox="1"/>
          <p:nvPr/>
        </p:nvSpPr>
        <p:spPr>
          <a:xfrm rot="17974481">
            <a:off x="4195789" y="1992923"/>
            <a:ext cx="15835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5-RNA ctrl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6" name="组合 15">
            <a:extLst>
              <a:ext uri="{FF2B5EF4-FFF2-40B4-BE49-F238E27FC236}">
                <a16:creationId xmlns:a16="http://schemas.microsoft.com/office/drawing/2014/main" id="{DAA19D4C-C0CD-874C-7BC0-E085551A3BA5}"/>
              </a:ext>
            </a:extLst>
          </p:cNvPr>
          <p:cNvGrpSpPr/>
          <p:nvPr/>
        </p:nvGrpSpPr>
        <p:grpSpPr>
          <a:xfrm>
            <a:off x="2025750" y="2059016"/>
            <a:ext cx="920678" cy="3342966"/>
            <a:chOff x="1913206" y="2466981"/>
            <a:chExt cx="920678" cy="3342966"/>
          </a:xfrm>
        </p:grpSpPr>
        <p:sp>
          <p:nvSpPr>
            <p:cNvPr id="17" name="右大括号 16">
              <a:extLst>
                <a:ext uri="{FF2B5EF4-FFF2-40B4-BE49-F238E27FC236}">
                  <a16:creationId xmlns:a16="http://schemas.microsoft.com/office/drawing/2014/main" id="{6B9289CA-3FCA-DF1C-6BA8-75518F223A5E}"/>
                </a:ext>
              </a:extLst>
            </p:cNvPr>
            <p:cNvSpPr/>
            <p:nvPr/>
          </p:nvSpPr>
          <p:spPr>
            <a:xfrm flipH="1">
              <a:off x="2559561" y="2466981"/>
              <a:ext cx="267287" cy="1260962"/>
            </a:xfrm>
            <a:prstGeom prst="rightBrac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zh-CN" altLang="en-US"/>
            </a:p>
          </p:txBody>
        </p:sp>
        <p:cxnSp>
          <p:nvCxnSpPr>
            <p:cNvPr id="18" name="直线连接符 17">
              <a:extLst>
                <a:ext uri="{FF2B5EF4-FFF2-40B4-BE49-F238E27FC236}">
                  <a16:creationId xmlns:a16="http://schemas.microsoft.com/office/drawing/2014/main" id="{38619CCC-1295-31F8-F00B-5F982B2AC9E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587697" y="3981159"/>
              <a:ext cx="246187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右大括号 18">
              <a:extLst>
                <a:ext uri="{FF2B5EF4-FFF2-40B4-BE49-F238E27FC236}">
                  <a16:creationId xmlns:a16="http://schemas.microsoft.com/office/drawing/2014/main" id="{8711EF58-D1AF-7850-F527-4DA3B19B7CED}"/>
                </a:ext>
              </a:extLst>
            </p:cNvPr>
            <p:cNvSpPr/>
            <p:nvPr/>
          </p:nvSpPr>
          <p:spPr>
            <a:xfrm flipH="1">
              <a:off x="2587697" y="4169946"/>
              <a:ext cx="207912" cy="1640001"/>
            </a:xfrm>
            <a:prstGeom prst="rightBrac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zh-CN" altLang="en-US"/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555E0A38-5993-43D1-5976-928F4DBB2289}"/>
                </a:ext>
              </a:extLst>
            </p:cNvPr>
            <p:cNvSpPr txBox="1"/>
            <p:nvPr/>
          </p:nvSpPr>
          <p:spPr>
            <a:xfrm>
              <a:off x="2250487" y="2879892"/>
              <a:ext cx="49236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2400" dirty="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endParaRPr kumimoji="1" lang="zh-CN" altLang="en-US" sz="2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13F31417-8273-DF74-718E-F32209BFA799}"/>
                </a:ext>
              </a:extLst>
            </p:cNvPr>
            <p:cNvSpPr txBox="1"/>
            <p:nvPr/>
          </p:nvSpPr>
          <p:spPr>
            <a:xfrm>
              <a:off x="2218421" y="4759113"/>
              <a:ext cx="49236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24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kumimoji="1" lang="zh-CN" altLang="en-US" sz="2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E949E09B-897E-3F73-CFA6-A59E51106955}"/>
                </a:ext>
              </a:extLst>
            </p:cNvPr>
            <p:cNvSpPr txBox="1"/>
            <p:nvPr/>
          </p:nvSpPr>
          <p:spPr>
            <a:xfrm>
              <a:off x="1913206" y="3755686"/>
              <a:ext cx="7425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20nt</a:t>
              </a:r>
              <a:endParaRPr kumimoji="1"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" name="文本框 2">
            <a:extLst>
              <a:ext uri="{FF2B5EF4-FFF2-40B4-BE49-F238E27FC236}">
                <a16:creationId xmlns:a16="http://schemas.microsoft.com/office/drawing/2014/main" id="{E470E81A-EA87-4C92-6B75-6FBC2456C799}"/>
              </a:ext>
            </a:extLst>
          </p:cNvPr>
          <p:cNvSpPr txBox="1"/>
          <p:nvPr/>
        </p:nvSpPr>
        <p:spPr>
          <a:xfrm rot="17974481">
            <a:off x="6092938" y="2012583"/>
            <a:ext cx="6189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D33EF96D-41C4-2D03-6B39-9339EBCC5DED}"/>
              </a:ext>
            </a:extLst>
          </p:cNvPr>
          <p:cNvSpPr txBox="1"/>
          <p:nvPr/>
        </p:nvSpPr>
        <p:spPr>
          <a:xfrm rot="17974481">
            <a:off x="6447665" y="2039557"/>
            <a:ext cx="6189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5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02CB2B60-CA82-CC06-9E81-C25C67E0BDB4}"/>
              </a:ext>
            </a:extLst>
          </p:cNvPr>
          <p:cNvSpPr txBox="1"/>
          <p:nvPr/>
        </p:nvSpPr>
        <p:spPr>
          <a:xfrm rot="17974481">
            <a:off x="6803187" y="2039556"/>
            <a:ext cx="6189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6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AFAE110B-8154-3159-9768-E55FCCA20F5D}"/>
              </a:ext>
            </a:extLst>
          </p:cNvPr>
          <p:cNvSpPr txBox="1"/>
          <p:nvPr/>
        </p:nvSpPr>
        <p:spPr>
          <a:xfrm rot="17974481">
            <a:off x="5586338" y="1845447"/>
            <a:ext cx="10653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3B8A7C82-F7BE-8738-0113-3B2014F862A1}"/>
              </a:ext>
            </a:extLst>
          </p:cNvPr>
          <p:cNvSpPr txBox="1"/>
          <p:nvPr/>
        </p:nvSpPr>
        <p:spPr>
          <a:xfrm rot="17974481">
            <a:off x="4538525" y="2006626"/>
            <a:ext cx="15493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6-RNA ctrl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3616501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D919D9FE-EF3D-3D17-3223-249E3ED42DFD}"/>
              </a:ext>
            </a:extLst>
          </p:cNvPr>
          <p:cNvSpPr txBox="1"/>
          <p:nvPr/>
        </p:nvSpPr>
        <p:spPr>
          <a:xfrm>
            <a:off x="2066133" y="241364"/>
            <a:ext cx="1881441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2800" b="1" dirty="0">
                <a:latin typeface="Arial" panose="020B0604020202020204" pitchFamily="34" charset="0"/>
                <a:cs typeface="Arial" panose="020B0604020202020204" pitchFamily="34" charset="0"/>
              </a:rPr>
              <a:t>Fig. 3C</a:t>
            </a:r>
          </a:p>
          <a:p>
            <a:r>
              <a:rPr kumimoji="1" lang="en-US" altLang="zh-CN" sz="2800" b="1" dirty="0">
                <a:latin typeface="Arial" panose="020B0604020202020204" pitchFamily="34" charset="0"/>
                <a:cs typeface="Arial" panose="020B0604020202020204" pitchFamily="34" charset="0"/>
              </a:rPr>
              <a:t>Repeat 2</a:t>
            </a:r>
            <a:endParaRPr kumimoji="1" lang="zh-CN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图片 17" descr="夜晚的星空&#10;&#10;中度可信度描述已自动生成">
            <a:extLst>
              <a:ext uri="{FF2B5EF4-FFF2-40B4-BE49-F238E27FC236}">
                <a16:creationId xmlns:a16="http://schemas.microsoft.com/office/drawing/2014/main" id="{F97C7B58-AF56-C1EC-14A0-F18400553A86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25865" y="1412642"/>
            <a:ext cx="6340270" cy="5072216"/>
          </a:xfrm>
          <a:prstGeom prst="rect">
            <a:avLst/>
          </a:prstGeom>
        </p:spPr>
      </p:pic>
      <p:grpSp>
        <p:nvGrpSpPr>
          <p:cNvPr id="19" name="组合 18">
            <a:extLst>
              <a:ext uri="{FF2B5EF4-FFF2-40B4-BE49-F238E27FC236}">
                <a16:creationId xmlns:a16="http://schemas.microsoft.com/office/drawing/2014/main" id="{D1D159E5-0740-A08F-43A6-4FDAE926266E}"/>
              </a:ext>
            </a:extLst>
          </p:cNvPr>
          <p:cNvGrpSpPr/>
          <p:nvPr/>
        </p:nvGrpSpPr>
        <p:grpSpPr>
          <a:xfrm>
            <a:off x="2011682" y="1932406"/>
            <a:ext cx="920678" cy="3342966"/>
            <a:chOff x="1913206" y="2466981"/>
            <a:chExt cx="920678" cy="3342966"/>
          </a:xfrm>
        </p:grpSpPr>
        <p:sp>
          <p:nvSpPr>
            <p:cNvPr id="20" name="右大括号 19">
              <a:extLst>
                <a:ext uri="{FF2B5EF4-FFF2-40B4-BE49-F238E27FC236}">
                  <a16:creationId xmlns:a16="http://schemas.microsoft.com/office/drawing/2014/main" id="{4A3F1FFA-906D-9585-0D22-7D8BCB5D3E67}"/>
                </a:ext>
              </a:extLst>
            </p:cNvPr>
            <p:cNvSpPr/>
            <p:nvPr/>
          </p:nvSpPr>
          <p:spPr>
            <a:xfrm flipH="1">
              <a:off x="2559561" y="2466981"/>
              <a:ext cx="267287" cy="1260962"/>
            </a:xfrm>
            <a:prstGeom prst="rightBrac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zh-CN" altLang="en-US"/>
            </a:p>
          </p:txBody>
        </p:sp>
        <p:cxnSp>
          <p:nvCxnSpPr>
            <p:cNvPr id="21" name="直线连接符 20">
              <a:extLst>
                <a:ext uri="{FF2B5EF4-FFF2-40B4-BE49-F238E27FC236}">
                  <a16:creationId xmlns:a16="http://schemas.microsoft.com/office/drawing/2014/main" id="{B8625BE0-4A96-63D8-B426-B2E19D92B28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587697" y="3981159"/>
              <a:ext cx="246187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右大括号 21">
              <a:extLst>
                <a:ext uri="{FF2B5EF4-FFF2-40B4-BE49-F238E27FC236}">
                  <a16:creationId xmlns:a16="http://schemas.microsoft.com/office/drawing/2014/main" id="{D9FE376E-8C03-AE86-895D-D69B8B5D76E4}"/>
                </a:ext>
              </a:extLst>
            </p:cNvPr>
            <p:cNvSpPr/>
            <p:nvPr/>
          </p:nvSpPr>
          <p:spPr>
            <a:xfrm flipH="1">
              <a:off x="2587697" y="4169946"/>
              <a:ext cx="207912" cy="1640001"/>
            </a:xfrm>
            <a:prstGeom prst="rightBrac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zh-CN" altLang="en-US"/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DE22B2EA-1C35-6433-0E26-D31922355DA1}"/>
                </a:ext>
              </a:extLst>
            </p:cNvPr>
            <p:cNvSpPr txBox="1"/>
            <p:nvPr/>
          </p:nvSpPr>
          <p:spPr>
            <a:xfrm>
              <a:off x="2250487" y="2879892"/>
              <a:ext cx="49236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2400" dirty="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endParaRPr kumimoji="1" lang="zh-CN" altLang="en-US" sz="2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611F45AF-09B2-1774-F702-F270FC704CAB}"/>
                </a:ext>
              </a:extLst>
            </p:cNvPr>
            <p:cNvSpPr txBox="1"/>
            <p:nvPr/>
          </p:nvSpPr>
          <p:spPr>
            <a:xfrm>
              <a:off x="2218421" y="4759113"/>
              <a:ext cx="49236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24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kumimoji="1" lang="zh-CN" altLang="en-US" sz="2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D6CFA135-47BE-69F6-964A-7B870C2188ED}"/>
                </a:ext>
              </a:extLst>
            </p:cNvPr>
            <p:cNvSpPr txBox="1"/>
            <p:nvPr/>
          </p:nvSpPr>
          <p:spPr>
            <a:xfrm>
              <a:off x="1913206" y="3755686"/>
              <a:ext cx="7425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20nt</a:t>
              </a:r>
              <a:endParaRPr kumimoji="1"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2" name="文本框 11">
            <a:extLst>
              <a:ext uri="{FF2B5EF4-FFF2-40B4-BE49-F238E27FC236}">
                <a16:creationId xmlns:a16="http://schemas.microsoft.com/office/drawing/2014/main" id="{0A9845E3-C1C3-5FA1-BA2C-20946C6EA3D0}"/>
              </a:ext>
            </a:extLst>
          </p:cNvPr>
          <p:cNvSpPr txBox="1"/>
          <p:nvPr/>
        </p:nvSpPr>
        <p:spPr>
          <a:xfrm rot="17974481">
            <a:off x="5728469" y="2057939"/>
            <a:ext cx="6189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C0CF32F6-1E27-0438-5E78-F1A9DF1DE04A}"/>
              </a:ext>
            </a:extLst>
          </p:cNvPr>
          <p:cNvSpPr txBox="1"/>
          <p:nvPr/>
        </p:nvSpPr>
        <p:spPr>
          <a:xfrm rot="17974481">
            <a:off x="6100018" y="2058156"/>
            <a:ext cx="6189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5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EE6652C7-2EF4-FF0F-2E44-B7D5BB3E7C8F}"/>
              </a:ext>
            </a:extLst>
          </p:cNvPr>
          <p:cNvSpPr txBox="1"/>
          <p:nvPr/>
        </p:nvSpPr>
        <p:spPr>
          <a:xfrm rot="17974481">
            <a:off x="6473222" y="2043871"/>
            <a:ext cx="6189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6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CE00BD94-1C66-1779-E27C-7E4B2CCA81B4}"/>
              </a:ext>
            </a:extLst>
          </p:cNvPr>
          <p:cNvSpPr txBox="1"/>
          <p:nvPr/>
        </p:nvSpPr>
        <p:spPr>
          <a:xfrm rot="17974481">
            <a:off x="5219016" y="1878330"/>
            <a:ext cx="10653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AE3615E3-7406-8B0B-336B-0B956AE4F3D3}"/>
              </a:ext>
            </a:extLst>
          </p:cNvPr>
          <p:cNvSpPr txBox="1"/>
          <p:nvPr/>
        </p:nvSpPr>
        <p:spPr>
          <a:xfrm rot="17974481">
            <a:off x="4278712" y="1842557"/>
            <a:ext cx="15835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5-RNA ctrl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9C648FA2-14A6-9702-04D7-726FFE1840A3}"/>
              </a:ext>
            </a:extLst>
          </p:cNvPr>
          <p:cNvSpPr txBox="1"/>
          <p:nvPr/>
        </p:nvSpPr>
        <p:spPr>
          <a:xfrm rot="17974481">
            <a:off x="4659564" y="1856558"/>
            <a:ext cx="15493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6-RNA ctrl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4141882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1FFBF321-DCAD-DA16-6E5E-3BD19080B2E6}"/>
              </a:ext>
            </a:extLst>
          </p:cNvPr>
          <p:cNvSpPr txBox="1"/>
          <p:nvPr/>
        </p:nvSpPr>
        <p:spPr>
          <a:xfrm>
            <a:off x="436967" y="265429"/>
            <a:ext cx="2831946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2800" b="1" dirty="0">
                <a:latin typeface="Arial" panose="020B0604020202020204" pitchFamily="34" charset="0"/>
                <a:cs typeface="Arial" panose="020B0604020202020204" pitchFamily="34" charset="0"/>
              </a:rPr>
              <a:t>Fig. 3C </a:t>
            </a:r>
          </a:p>
          <a:p>
            <a:r>
              <a:rPr kumimoji="1" lang="en-US" altLang="zh-CN" sz="2800" b="1" dirty="0">
                <a:latin typeface="Arial" panose="020B0604020202020204" pitchFamily="34" charset="0"/>
                <a:cs typeface="Arial" panose="020B0604020202020204" pitchFamily="34" charset="0"/>
              </a:rPr>
              <a:t>Repeats 3 &amp; 4</a:t>
            </a:r>
            <a:endParaRPr kumimoji="1" lang="zh-CN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图片 11">
            <a:extLst>
              <a:ext uri="{FF2B5EF4-FFF2-40B4-BE49-F238E27FC236}">
                <a16:creationId xmlns:a16="http://schemas.microsoft.com/office/drawing/2014/main" id="{45DBFCBF-29F3-F805-95C7-20D4AA910FD0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81187" y="1387794"/>
            <a:ext cx="6266255" cy="5013005"/>
          </a:xfrm>
          <a:prstGeom prst="rect">
            <a:avLst/>
          </a:prstGeom>
        </p:spPr>
      </p:pic>
      <p:sp>
        <p:nvSpPr>
          <p:cNvPr id="13" name="文本框 12">
            <a:extLst>
              <a:ext uri="{FF2B5EF4-FFF2-40B4-BE49-F238E27FC236}">
                <a16:creationId xmlns:a16="http://schemas.microsoft.com/office/drawing/2014/main" id="{DAAE96A6-D337-3776-2882-8B7314EE4168}"/>
              </a:ext>
            </a:extLst>
          </p:cNvPr>
          <p:cNvSpPr txBox="1"/>
          <p:nvPr/>
        </p:nvSpPr>
        <p:spPr>
          <a:xfrm rot="17974481">
            <a:off x="4835181" y="2214507"/>
            <a:ext cx="6189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FA6B195D-AA0C-7B4A-243E-932569F22E11}"/>
              </a:ext>
            </a:extLst>
          </p:cNvPr>
          <p:cNvSpPr txBox="1"/>
          <p:nvPr/>
        </p:nvSpPr>
        <p:spPr>
          <a:xfrm rot="17974481">
            <a:off x="5189908" y="2241481"/>
            <a:ext cx="6189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5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0E94ABC3-3196-6418-0AA4-209099C7B536}"/>
              </a:ext>
            </a:extLst>
          </p:cNvPr>
          <p:cNvSpPr txBox="1"/>
          <p:nvPr/>
        </p:nvSpPr>
        <p:spPr>
          <a:xfrm rot="17974481">
            <a:off x="5556719" y="2241480"/>
            <a:ext cx="6189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6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FC57CC47-620F-5A4F-CB16-0B493716C98B}"/>
              </a:ext>
            </a:extLst>
          </p:cNvPr>
          <p:cNvSpPr txBox="1"/>
          <p:nvPr/>
        </p:nvSpPr>
        <p:spPr>
          <a:xfrm rot="17974481">
            <a:off x="4308874" y="2047371"/>
            <a:ext cx="10653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33D756BC-7968-C053-C9DA-021291F35DC0}"/>
              </a:ext>
            </a:extLst>
          </p:cNvPr>
          <p:cNvSpPr txBox="1"/>
          <p:nvPr/>
        </p:nvSpPr>
        <p:spPr>
          <a:xfrm rot="17974481">
            <a:off x="6754781" y="2171049"/>
            <a:ext cx="6189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772C5EF3-3B8B-311D-6722-90416EF86F7E}"/>
              </a:ext>
            </a:extLst>
          </p:cNvPr>
          <p:cNvSpPr txBox="1"/>
          <p:nvPr/>
        </p:nvSpPr>
        <p:spPr>
          <a:xfrm rot="17974481">
            <a:off x="7053063" y="2198023"/>
            <a:ext cx="6189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5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83FAB27B-2A86-18F9-B08A-CF231CB593F1}"/>
              </a:ext>
            </a:extLst>
          </p:cNvPr>
          <p:cNvSpPr txBox="1"/>
          <p:nvPr/>
        </p:nvSpPr>
        <p:spPr>
          <a:xfrm rot="17974481">
            <a:off x="7397296" y="2198022"/>
            <a:ext cx="6189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6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36457E7E-445C-D974-B1B5-7F86F9E556B2}"/>
              </a:ext>
            </a:extLst>
          </p:cNvPr>
          <p:cNvSpPr txBox="1"/>
          <p:nvPr/>
        </p:nvSpPr>
        <p:spPr>
          <a:xfrm rot="17974481">
            <a:off x="6262341" y="2003913"/>
            <a:ext cx="10653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1" name="组合 20">
            <a:extLst>
              <a:ext uri="{FF2B5EF4-FFF2-40B4-BE49-F238E27FC236}">
                <a16:creationId xmlns:a16="http://schemas.microsoft.com/office/drawing/2014/main" id="{BDD21272-6E18-F950-BA81-2BD98202B436}"/>
              </a:ext>
            </a:extLst>
          </p:cNvPr>
          <p:cNvGrpSpPr/>
          <p:nvPr/>
        </p:nvGrpSpPr>
        <p:grpSpPr>
          <a:xfrm>
            <a:off x="2560323" y="2565457"/>
            <a:ext cx="920678" cy="3342966"/>
            <a:chOff x="1913206" y="2466981"/>
            <a:chExt cx="920678" cy="3342966"/>
          </a:xfrm>
        </p:grpSpPr>
        <p:sp>
          <p:nvSpPr>
            <p:cNvPr id="22" name="右大括号 21">
              <a:extLst>
                <a:ext uri="{FF2B5EF4-FFF2-40B4-BE49-F238E27FC236}">
                  <a16:creationId xmlns:a16="http://schemas.microsoft.com/office/drawing/2014/main" id="{46DAB81E-DD8F-6755-5C91-E4FB3F188F4D}"/>
                </a:ext>
              </a:extLst>
            </p:cNvPr>
            <p:cNvSpPr/>
            <p:nvPr/>
          </p:nvSpPr>
          <p:spPr>
            <a:xfrm flipH="1">
              <a:off x="2559561" y="2466981"/>
              <a:ext cx="267287" cy="1260962"/>
            </a:xfrm>
            <a:prstGeom prst="rightBrac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zh-CN" altLang="en-US"/>
            </a:p>
          </p:txBody>
        </p:sp>
        <p:cxnSp>
          <p:nvCxnSpPr>
            <p:cNvPr id="23" name="直线连接符 22">
              <a:extLst>
                <a:ext uri="{FF2B5EF4-FFF2-40B4-BE49-F238E27FC236}">
                  <a16:creationId xmlns:a16="http://schemas.microsoft.com/office/drawing/2014/main" id="{C1CD667E-776F-932C-FFE3-01B43EE8BBF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587697" y="3981159"/>
              <a:ext cx="246187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右大括号 23">
              <a:extLst>
                <a:ext uri="{FF2B5EF4-FFF2-40B4-BE49-F238E27FC236}">
                  <a16:creationId xmlns:a16="http://schemas.microsoft.com/office/drawing/2014/main" id="{432D0C0E-DAEB-8940-EA67-B9C028EF6E28}"/>
                </a:ext>
              </a:extLst>
            </p:cNvPr>
            <p:cNvSpPr/>
            <p:nvPr/>
          </p:nvSpPr>
          <p:spPr>
            <a:xfrm flipH="1">
              <a:off x="2587697" y="4169946"/>
              <a:ext cx="207912" cy="1640001"/>
            </a:xfrm>
            <a:prstGeom prst="rightBrac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zh-CN" altLang="en-US"/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1B1850A2-DAA4-1305-3C27-4493918965A7}"/>
                </a:ext>
              </a:extLst>
            </p:cNvPr>
            <p:cNvSpPr txBox="1"/>
            <p:nvPr/>
          </p:nvSpPr>
          <p:spPr>
            <a:xfrm>
              <a:off x="2250487" y="2879892"/>
              <a:ext cx="49236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2400" dirty="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endParaRPr kumimoji="1" lang="zh-CN" altLang="en-US" sz="2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119DC89B-5F82-80D2-96D8-D8B98C8C32FC}"/>
                </a:ext>
              </a:extLst>
            </p:cNvPr>
            <p:cNvSpPr txBox="1"/>
            <p:nvPr/>
          </p:nvSpPr>
          <p:spPr>
            <a:xfrm>
              <a:off x="2218421" y="4759113"/>
              <a:ext cx="49236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24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kumimoji="1" lang="zh-CN" altLang="en-US" sz="2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B4173D2F-DFEC-4CFC-8F09-59FC4197208E}"/>
                </a:ext>
              </a:extLst>
            </p:cNvPr>
            <p:cNvSpPr txBox="1"/>
            <p:nvPr/>
          </p:nvSpPr>
          <p:spPr>
            <a:xfrm>
              <a:off x="1913206" y="3755686"/>
              <a:ext cx="7425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20nt</a:t>
              </a:r>
              <a:endParaRPr kumimoji="1"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8" name="矩形 27">
            <a:extLst>
              <a:ext uri="{FF2B5EF4-FFF2-40B4-BE49-F238E27FC236}">
                <a16:creationId xmlns:a16="http://schemas.microsoft.com/office/drawing/2014/main" id="{39F1CB5C-67F7-2C47-A831-84183CCA6F61}"/>
              </a:ext>
            </a:extLst>
          </p:cNvPr>
          <p:cNvSpPr/>
          <p:nvPr/>
        </p:nvSpPr>
        <p:spPr>
          <a:xfrm>
            <a:off x="4627709" y="704076"/>
            <a:ext cx="127470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1"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Repeats 3</a:t>
            </a:r>
            <a:endParaRPr lang="zh-CN" altLang="en-US" dirty="0"/>
          </a:p>
        </p:txBody>
      </p:sp>
      <p:sp>
        <p:nvSpPr>
          <p:cNvPr id="29" name="左大括号 28">
            <a:extLst>
              <a:ext uri="{FF2B5EF4-FFF2-40B4-BE49-F238E27FC236}">
                <a16:creationId xmlns:a16="http://schemas.microsoft.com/office/drawing/2014/main" id="{11481916-240F-D343-A4A7-D0C3DE006C15}"/>
              </a:ext>
            </a:extLst>
          </p:cNvPr>
          <p:cNvSpPr/>
          <p:nvPr/>
        </p:nvSpPr>
        <p:spPr>
          <a:xfrm rot="5400000">
            <a:off x="5158603" y="461397"/>
            <a:ext cx="231252" cy="1509223"/>
          </a:xfrm>
          <a:prstGeom prst="leftBrace">
            <a:avLst/>
          </a:prstGeom>
          <a:ln w="317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zh-CN" altLang="en-US" dirty="0"/>
          </a:p>
        </p:txBody>
      </p:sp>
      <p:sp>
        <p:nvSpPr>
          <p:cNvPr id="30" name="左大括号 29">
            <a:extLst>
              <a:ext uri="{FF2B5EF4-FFF2-40B4-BE49-F238E27FC236}">
                <a16:creationId xmlns:a16="http://schemas.microsoft.com/office/drawing/2014/main" id="{0392094F-76F6-6B46-9FCF-06DFA6013F0E}"/>
              </a:ext>
            </a:extLst>
          </p:cNvPr>
          <p:cNvSpPr/>
          <p:nvPr/>
        </p:nvSpPr>
        <p:spPr>
          <a:xfrm rot="5400000">
            <a:off x="7025990" y="446631"/>
            <a:ext cx="231252" cy="1509223"/>
          </a:xfrm>
          <a:prstGeom prst="leftBrace">
            <a:avLst/>
          </a:prstGeom>
          <a:ln w="317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zh-CN" altLang="en-US" dirty="0"/>
          </a:p>
        </p:txBody>
      </p:sp>
      <p:sp>
        <p:nvSpPr>
          <p:cNvPr id="31" name="矩形 30">
            <a:extLst>
              <a:ext uri="{FF2B5EF4-FFF2-40B4-BE49-F238E27FC236}">
                <a16:creationId xmlns:a16="http://schemas.microsoft.com/office/drawing/2014/main" id="{F81024C4-B629-754E-9AA0-12099573327B}"/>
              </a:ext>
            </a:extLst>
          </p:cNvPr>
          <p:cNvSpPr/>
          <p:nvPr/>
        </p:nvSpPr>
        <p:spPr>
          <a:xfrm>
            <a:off x="6504262" y="715776"/>
            <a:ext cx="127470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1"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Repeats 4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65900658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66907F79-6D18-6521-8A72-5FD6A5A9C380}"/>
              </a:ext>
            </a:extLst>
          </p:cNvPr>
          <p:cNvSpPr txBox="1"/>
          <p:nvPr/>
        </p:nvSpPr>
        <p:spPr>
          <a:xfrm>
            <a:off x="2009636" y="499997"/>
            <a:ext cx="1881441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2800" b="1" dirty="0">
                <a:latin typeface="Arial" panose="020B0604020202020204" pitchFamily="34" charset="0"/>
                <a:cs typeface="Arial" panose="020B0604020202020204" pitchFamily="34" charset="0"/>
              </a:rPr>
              <a:t>Fig. 3D</a:t>
            </a:r>
          </a:p>
          <a:p>
            <a:r>
              <a:rPr kumimoji="1" lang="en-US" altLang="zh-CN" sz="2800" b="1" dirty="0">
                <a:latin typeface="Arial" panose="020B0604020202020204" pitchFamily="34" charset="0"/>
                <a:cs typeface="Arial" panose="020B0604020202020204" pitchFamily="34" charset="0"/>
              </a:rPr>
              <a:t>Repeat 1</a:t>
            </a:r>
            <a:endParaRPr kumimoji="1" lang="zh-CN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图片 11">
            <a:extLst>
              <a:ext uri="{FF2B5EF4-FFF2-40B4-BE49-F238E27FC236}">
                <a16:creationId xmlns:a16="http://schemas.microsoft.com/office/drawing/2014/main" id="{FFCA8A2A-506A-B8DA-62B9-08612D5065C2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94240" y="1707320"/>
            <a:ext cx="5932417" cy="4745933"/>
          </a:xfrm>
          <a:prstGeom prst="rect">
            <a:avLst/>
          </a:prstGeom>
        </p:spPr>
      </p:pic>
      <p:grpSp>
        <p:nvGrpSpPr>
          <p:cNvPr id="15" name="组合 14">
            <a:extLst>
              <a:ext uri="{FF2B5EF4-FFF2-40B4-BE49-F238E27FC236}">
                <a16:creationId xmlns:a16="http://schemas.microsoft.com/office/drawing/2014/main" id="{F90E0219-B943-D871-31D5-2D0DE58B1555}"/>
              </a:ext>
            </a:extLst>
          </p:cNvPr>
          <p:cNvGrpSpPr/>
          <p:nvPr/>
        </p:nvGrpSpPr>
        <p:grpSpPr>
          <a:xfrm>
            <a:off x="2067954" y="1890197"/>
            <a:ext cx="920678" cy="3342966"/>
            <a:chOff x="1913206" y="2466981"/>
            <a:chExt cx="920678" cy="3342966"/>
          </a:xfrm>
        </p:grpSpPr>
        <p:sp>
          <p:nvSpPr>
            <p:cNvPr id="16" name="右大括号 15">
              <a:extLst>
                <a:ext uri="{FF2B5EF4-FFF2-40B4-BE49-F238E27FC236}">
                  <a16:creationId xmlns:a16="http://schemas.microsoft.com/office/drawing/2014/main" id="{35B83088-ADE7-91C0-459C-C38AA7CBBA8B}"/>
                </a:ext>
              </a:extLst>
            </p:cNvPr>
            <p:cNvSpPr/>
            <p:nvPr/>
          </p:nvSpPr>
          <p:spPr>
            <a:xfrm flipH="1">
              <a:off x="2559561" y="2466981"/>
              <a:ext cx="267287" cy="1260962"/>
            </a:xfrm>
            <a:prstGeom prst="rightBrac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zh-CN" altLang="en-US"/>
            </a:p>
          </p:txBody>
        </p:sp>
        <p:cxnSp>
          <p:nvCxnSpPr>
            <p:cNvPr id="17" name="直线连接符 16">
              <a:extLst>
                <a:ext uri="{FF2B5EF4-FFF2-40B4-BE49-F238E27FC236}">
                  <a16:creationId xmlns:a16="http://schemas.microsoft.com/office/drawing/2014/main" id="{04A8A88D-DDF8-1E85-6FE8-BE5FCF02867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587697" y="3981159"/>
              <a:ext cx="246187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右大括号 17">
              <a:extLst>
                <a:ext uri="{FF2B5EF4-FFF2-40B4-BE49-F238E27FC236}">
                  <a16:creationId xmlns:a16="http://schemas.microsoft.com/office/drawing/2014/main" id="{226655D8-74C3-E73D-6DBC-233C0C2EC00B}"/>
                </a:ext>
              </a:extLst>
            </p:cNvPr>
            <p:cNvSpPr/>
            <p:nvPr/>
          </p:nvSpPr>
          <p:spPr>
            <a:xfrm flipH="1">
              <a:off x="2587697" y="4169946"/>
              <a:ext cx="207912" cy="1640001"/>
            </a:xfrm>
            <a:prstGeom prst="rightBrac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zh-CN" altLang="en-US"/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9CFE46CB-2242-E577-407B-673125C76D54}"/>
                </a:ext>
              </a:extLst>
            </p:cNvPr>
            <p:cNvSpPr txBox="1"/>
            <p:nvPr/>
          </p:nvSpPr>
          <p:spPr>
            <a:xfrm>
              <a:off x="2250487" y="2879892"/>
              <a:ext cx="49236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2400" dirty="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endParaRPr kumimoji="1" lang="zh-CN" altLang="en-US" sz="2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2C784004-8802-D5C6-D4DF-52FA0157EF40}"/>
                </a:ext>
              </a:extLst>
            </p:cNvPr>
            <p:cNvSpPr txBox="1"/>
            <p:nvPr/>
          </p:nvSpPr>
          <p:spPr>
            <a:xfrm>
              <a:off x="2218421" y="4759113"/>
              <a:ext cx="49236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24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kumimoji="1" lang="zh-CN" altLang="en-US" sz="2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5BF93EB8-084C-6CF2-850F-F3E91D3F01B6}"/>
                </a:ext>
              </a:extLst>
            </p:cNvPr>
            <p:cNvSpPr txBox="1"/>
            <p:nvPr/>
          </p:nvSpPr>
          <p:spPr>
            <a:xfrm>
              <a:off x="1913206" y="3755686"/>
              <a:ext cx="7425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20nt</a:t>
              </a:r>
              <a:endParaRPr kumimoji="1"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" name="文本框 2">
            <a:extLst>
              <a:ext uri="{FF2B5EF4-FFF2-40B4-BE49-F238E27FC236}">
                <a16:creationId xmlns:a16="http://schemas.microsoft.com/office/drawing/2014/main" id="{869D4569-63E3-3264-B949-52151C8A5AA6}"/>
              </a:ext>
            </a:extLst>
          </p:cNvPr>
          <p:cNvSpPr txBox="1"/>
          <p:nvPr/>
        </p:nvSpPr>
        <p:spPr>
          <a:xfrm rot="17974481">
            <a:off x="6712478" y="2364562"/>
            <a:ext cx="6189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1E4CD0B7-F322-ED54-14BC-A8BA6C94972C}"/>
              </a:ext>
            </a:extLst>
          </p:cNvPr>
          <p:cNvSpPr txBox="1"/>
          <p:nvPr/>
        </p:nvSpPr>
        <p:spPr>
          <a:xfrm rot="17974481">
            <a:off x="6990112" y="2363399"/>
            <a:ext cx="6189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1DFE0D8A-CC11-F93F-EB44-FF839E01A924}"/>
              </a:ext>
            </a:extLst>
          </p:cNvPr>
          <p:cNvSpPr txBox="1"/>
          <p:nvPr/>
        </p:nvSpPr>
        <p:spPr>
          <a:xfrm rot="17974481">
            <a:off x="7284593" y="2363399"/>
            <a:ext cx="6189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7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0891FC35-263F-6FFC-D7E1-F38B04261FA7}"/>
              </a:ext>
            </a:extLst>
          </p:cNvPr>
          <p:cNvSpPr txBox="1"/>
          <p:nvPr/>
        </p:nvSpPr>
        <p:spPr>
          <a:xfrm rot="17974481">
            <a:off x="7590364" y="2363399"/>
            <a:ext cx="6189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8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9D2AE15B-AD97-3337-1446-7F132FF15E86}"/>
              </a:ext>
            </a:extLst>
          </p:cNvPr>
          <p:cNvSpPr txBox="1"/>
          <p:nvPr/>
        </p:nvSpPr>
        <p:spPr>
          <a:xfrm rot="17974481">
            <a:off x="4147170" y="2091871"/>
            <a:ext cx="15835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1-RNA ctrl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17ADF744-2BAC-10BB-C887-7D0F94DFE5C5}"/>
              </a:ext>
            </a:extLst>
          </p:cNvPr>
          <p:cNvSpPr txBox="1"/>
          <p:nvPr/>
        </p:nvSpPr>
        <p:spPr>
          <a:xfrm rot="17974481">
            <a:off x="4512484" y="2105574"/>
            <a:ext cx="15493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2-RNA ctrl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9ECB73E0-6B82-88E0-F04A-352C05DCD77B}"/>
              </a:ext>
            </a:extLst>
          </p:cNvPr>
          <p:cNvSpPr txBox="1"/>
          <p:nvPr/>
        </p:nvSpPr>
        <p:spPr>
          <a:xfrm rot="17974481">
            <a:off x="4903814" y="2078026"/>
            <a:ext cx="16127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7-RNA ctrl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DC423FFB-24D4-D18B-EC63-FCD330055C8D}"/>
              </a:ext>
            </a:extLst>
          </p:cNvPr>
          <p:cNvSpPr txBox="1"/>
          <p:nvPr/>
        </p:nvSpPr>
        <p:spPr>
          <a:xfrm rot="17974481">
            <a:off x="5318798" y="2110486"/>
            <a:ext cx="15380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8-RNA ctrl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5D73B3BD-01ED-BF2D-6505-C26CA9441D60}"/>
              </a:ext>
            </a:extLst>
          </p:cNvPr>
          <p:cNvSpPr txBox="1"/>
          <p:nvPr/>
        </p:nvSpPr>
        <p:spPr>
          <a:xfrm rot="17974481">
            <a:off x="6225581" y="2168128"/>
            <a:ext cx="10653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71C71D90-457D-D7D0-A14D-2A9ECA69C12A}"/>
              </a:ext>
            </a:extLst>
          </p:cNvPr>
          <p:cNvSpPr txBox="1"/>
          <p:nvPr/>
        </p:nvSpPr>
        <p:spPr>
          <a:xfrm rot="17974481">
            <a:off x="7907422" y="2363400"/>
            <a:ext cx="6189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9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163824F3-5915-8168-D57B-62C54AFB69C9}"/>
              </a:ext>
            </a:extLst>
          </p:cNvPr>
          <p:cNvSpPr txBox="1"/>
          <p:nvPr/>
        </p:nvSpPr>
        <p:spPr>
          <a:xfrm rot="17974481">
            <a:off x="5702709" y="2107179"/>
            <a:ext cx="15380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9-RNA ctrl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0293381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601FC302-CA91-1C03-DAE0-4CC567198759}"/>
              </a:ext>
            </a:extLst>
          </p:cNvPr>
          <p:cNvSpPr txBox="1"/>
          <p:nvPr/>
        </p:nvSpPr>
        <p:spPr>
          <a:xfrm>
            <a:off x="386911" y="275967"/>
            <a:ext cx="277122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2800" b="1" dirty="0">
                <a:latin typeface="Arial" panose="020B0604020202020204" pitchFamily="34" charset="0"/>
                <a:cs typeface="Arial" panose="020B0604020202020204" pitchFamily="34" charset="0"/>
              </a:rPr>
              <a:t>Fig. 3D</a:t>
            </a:r>
          </a:p>
          <a:p>
            <a:r>
              <a:rPr kumimoji="1" lang="en-US" altLang="zh-CN" sz="2800" b="1" dirty="0">
                <a:latin typeface="Arial" panose="020B0604020202020204" pitchFamily="34" charset="0"/>
                <a:cs typeface="Arial" panose="020B0604020202020204" pitchFamily="34" charset="0"/>
              </a:rPr>
              <a:t>Repeats 2 &amp; 3</a:t>
            </a:r>
            <a:endParaRPr kumimoji="1" lang="zh-CN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图片 11" descr="图片包含 黑暗, 灯光, 大, 亮&#10;&#10;描述已自动生成">
            <a:extLst>
              <a:ext uri="{FF2B5EF4-FFF2-40B4-BE49-F238E27FC236}">
                <a16:creationId xmlns:a16="http://schemas.microsoft.com/office/drawing/2014/main" id="{494A7259-FD18-2E59-9187-1ADB03B5BFAE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89379" y="1277396"/>
            <a:ext cx="6675126" cy="5340101"/>
          </a:xfrm>
          <a:prstGeom prst="rect">
            <a:avLst/>
          </a:prstGeom>
        </p:spPr>
      </p:pic>
      <p:grpSp>
        <p:nvGrpSpPr>
          <p:cNvPr id="20" name="组合 19">
            <a:extLst>
              <a:ext uri="{FF2B5EF4-FFF2-40B4-BE49-F238E27FC236}">
                <a16:creationId xmlns:a16="http://schemas.microsoft.com/office/drawing/2014/main" id="{33D37505-B010-BD6A-67B9-EA74B4E3FBDB}"/>
              </a:ext>
            </a:extLst>
          </p:cNvPr>
          <p:cNvGrpSpPr/>
          <p:nvPr/>
        </p:nvGrpSpPr>
        <p:grpSpPr>
          <a:xfrm>
            <a:off x="2096089" y="1819864"/>
            <a:ext cx="920678" cy="3342966"/>
            <a:chOff x="1913206" y="2466981"/>
            <a:chExt cx="920678" cy="3342966"/>
          </a:xfrm>
        </p:grpSpPr>
        <p:sp>
          <p:nvSpPr>
            <p:cNvPr id="21" name="右大括号 20">
              <a:extLst>
                <a:ext uri="{FF2B5EF4-FFF2-40B4-BE49-F238E27FC236}">
                  <a16:creationId xmlns:a16="http://schemas.microsoft.com/office/drawing/2014/main" id="{2FC1D261-1040-CB35-9844-47D2C579249F}"/>
                </a:ext>
              </a:extLst>
            </p:cNvPr>
            <p:cNvSpPr/>
            <p:nvPr/>
          </p:nvSpPr>
          <p:spPr>
            <a:xfrm flipH="1">
              <a:off x="2559561" y="2466981"/>
              <a:ext cx="267287" cy="1260962"/>
            </a:xfrm>
            <a:prstGeom prst="rightBrac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zh-CN" altLang="en-US"/>
            </a:p>
          </p:txBody>
        </p:sp>
        <p:cxnSp>
          <p:nvCxnSpPr>
            <p:cNvPr id="22" name="直线连接符 21">
              <a:extLst>
                <a:ext uri="{FF2B5EF4-FFF2-40B4-BE49-F238E27FC236}">
                  <a16:creationId xmlns:a16="http://schemas.microsoft.com/office/drawing/2014/main" id="{B1740248-4AA3-A75B-5FC4-06B39170C19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587697" y="3981159"/>
              <a:ext cx="246187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右大括号 22">
              <a:extLst>
                <a:ext uri="{FF2B5EF4-FFF2-40B4-BE49-F238E27FC236}">
                  <a16:creationId xmlns:a16="http://schemas.microsoft.com/office/drawing/2014/main" id="{75A406D6-EA8D-C442-5C12-179C360C1E05}"/>
                </a:ext>
              </a:extLst>
            </p:cNvPr>
            <p:cNvSpPr/>
            <p:nvPr/>
          </p:nvSpPr>
          <p:spPr>
            <a:xfrm flipH="1">
              <a:off x="2587697" y="4169946"/>
              <a:ext cx="207912" cy="1640001"/>
            </a:xfrm>
            <a:prstGeom prst="rightBrac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zh-CN" altLang="en-US"/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433A8F66-D8F9-5410-E352-449849772299}"/>
                </a:ext>
              </a:extLst>
            </p:cNvPr>
            <p:cNvSpPr txBox="1"/>
            <p:nvPr/>
          </p:nvSpPr>
          <p:spPr>
            <a:xfrm>
              <a:off x="2250487" y="2879892"/>
              <a:ext cx="49236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2400" dirty="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endParaRPr kumimoji="1" lang="zh-CN" altLang="en-US" sz="2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30416ADB-A0AB-BB72-82E4-9AE93F1955E5}"/>
                </a:ext>
              </a:extLst>
            </p:cNvPr>
            <p:cNvSpPr txBox="1"/>
            <p:nvPr/>
          </p:nvSpPr>
          <p:spPr>
            <a:xfrm>
              <a:off x="2218421" y="4759113"/>
              <a:ext cx="49236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24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kumimoji="1" lang="zh-CN" altLang="en-US" sz="2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6A3A0E84-E930-3542-9254-6A75C2B5F1C4}"/>
                </a:ext>
              </a:extLst>
            </p:cNvPr>
            <p:cNvSpPr txBox="1"/>
            <p:nvPr/>
          </p:nvSpPr>
          <p:spPr>
            <a:xfrm>
              <a:off x="1913206" y="3755686"/>
              <a:ext cx="7425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20nt</a:t>
              </a:r>
              <a:endParaRPr kumimoji="1"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" name="文本框 2">
            <a:extLst>
              <a:ext uri="{FF2B5EF4-FFF2-40B4-BE49-F238E27FC236}">
                <a16:creationId xmlns:a16="http://schemas.microsoft.com/office/drawing/2014/main" id="{6CE4C50A-B502-9839-0F00-B95DC9CE87BB}"/>
              </a:ext>
            </a:extLst>
          </p:cNvPr>
          <p:cNvSpPr txBox="1"/>
          <p:nvPr/>
        </p:nvSpPr>
        <p:spPr>
          <a:xfrm rot="17974481">
            <a:off x="4364278" y="1529178"/>
            <a:ext cx="6189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9523F91E-B8A5-82B2-8142-BA3010B35694}"/>
              </a:ext>
            </a:extLst>
          </p:cNvPr>
          <p:cNvSpPr txBox="1"/>
          <p:nvPr/>
        </p:nvSpPr>
        <p:spPr>
          <a:xfrm rot="17974481">
            <a:off x="4675779" y="1528015"/>
            <a:ext cx="6189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F3106688-709B-6208-4451-752CD03FECF9}"/>
              </a:ext>
            </a:extLst>
          </p:cNvPr>
          <p:cNvSpPr txBox="1"/>
          <p:nvPr/>
        </p:nvSpPr>
        <p:spPr>
          <a:xfrm rot="17974481">
            <a:off x="5071861" y="1528015"/>
            <a:ext cx="6189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7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4758BD40-0B79-1C57-F7FE-520A138E252B}"/>
              </a:ext>
            </a:extLst>
          </p:cNvPr>
          <p:cNvSpPr txBox="1"/>
          <p:nvPr/>
        </p:nvSpPr>
        <p:spPr>
          <a:xfrm rot="17974481">
            <a:off x="5411499" y="1528015"/>
            <a:ext cx="6189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8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C8AA3F5D-2978-7DBA-E8A8-F9156F44325F}"/>
              </a:ext>
            </a:extLst>
          </p:cNvPr>
          <p:cNvSpPr txBox="1"/>
          <p:nvPr/>
        </p:nvSpPr>
        <p:spPr>
          <a:xfrm rot="17974481">
            <a:off x="3854803" y="1332744"/>
            <a:ext cx="10653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E52E5401-D86E-118A-369B-A8981B543402}"/>
              </a:ext>
            </a:extLst>
          </p:cNvPr>
          <p:cNvSpPr txBox="1"/>
          <p:nvPr/>
        </p:nvSpPr>
        <p:spPr>
          <a:xfrm rot="17974481">
            <a:off x="5807580" y="1528016"/>
            <a:ext cx="6189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9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3194757C-18E6-9C51-1BDE-762F54C4A0A8}"/>
              </a:ext>
            </a:extLst>
          </p:cNvPr>
          <p:cNvSpPr txBox="1"/>
          <p:nvPr/>
        </p:nvSpPr>
        <p:spPr>
          <a:xfrm rot="17974481">
            <a:off x="6627359" y="1529177"/>
            <a:ext cx="6189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6C5046AB-0068-E222-A119-F76129B617D0}"/>
              </a:ext>
            </a:extLst>
          </p:cNvPr>
          <p:cNvSpPr txBox="1"/>
          <p:nvPr/>
        </p:nvSpPr>
        <p:spPr>
          <a:xfrm rot="17974481">
            <a:off x="6961438" y="1528014"/>
            <a:ext cx="6189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6F1EB866-D6B8-66E3-2D3D-A24CCFD567F1}"/>
              </a:ext>
            </a:extLst>
          </p:cNvPr>
          <p:cNvSpPr txBox="1"/>
          <p:nvPr/>
        </p:nvSpPr>
        <p:spPr>
          <a:xfrm rot="17974481">
            <a:off x="7323653" y="1528014"/>
            <a:ext cx="6189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7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08DF1E5F-C7A5-1DBE-3BD3-DEE153E65262}"/>
              </a:ext>
            </a:extLst>
          </p:cNvPr>
          <p:cNvSpPr txBox="1"/>
          <p:nvPr/>
        </p:nvSpPr>
        <p:spPr>
          <a:xfrm rot="17974481">
            <a:off x="7685869" y="1528014"/>
            <a:ext cx="6189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8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8D0827D0-8A83-A9B6-E7F0-17CE9F2EBED2}"/>
              </a:ext>
            </a:extLst>
          </p:cNvPr>
          <p:cNvSpPr txBox="1"/>
          <p:nvPr/>
        </p:nvSpPr>
        <p:spPr>
          <a:xfrm rot="17974481">
            <a:off x="6140462" y="1332743"/>
            <a:ext cx="10653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41CF1F44-904C-5C0D-3CC1-49FE372524F2}"/>
              </a:ext>
            </a:extLst>
          </p:cNvPr>
          <p:cNvSpPr txBox="1"/>
          <p:nvPr/>
        </p:nvSpPr>
        <p:spPr>
          <a:xfrm rot="17974481">
            <a:off x="8048083" y="1528015"/>
            <a:ext cx="6189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9</a:t>
            </a:r>
            <a:endParaRPr kumimoji="1"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左大括号 9">
            <a:extLst>
              <a:ext uri="{FF2B5EF4-FFF2-40B4-BE49-F238E27FC236}">
                <a16:creationId xmlns:a16="http://schemas.microsoft.com/office/drawing/2014/main" id="{8CA4A05F-C9C0-D646-9DB3-AD086595C1DA}"/>
              </a:ext>
            </a:extLst>
          </p:cNvPr>
          <p:cNvSpPr/>
          <p:nvPr/>
        </p:nvSpPr>
        <p:spPr>
          <a:xfrm rot="5400000">
            <a:off x="5009517" y="-30519"/>
            <a:ext cx="248924" cy="2231295"/>
          </a:xfrm>
          <a:prstGeom prst="leftBrace">
            <a:avLst/>
          </a:prstGeom>
          <a:ln w="317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zh-CN" altLang="en-US" dirty="0"/>
          </a:p>
        </p:txBody>
      </p:sp>
      <p:sp>
        <p:nvSpPr>
          <p:cNvPr id="30" name="矩形 29">
            <a:extLst>
              <a:ext uri="{FF2B5EF4-FFF2-40B4-BE49-F238E27FC236}">
                <a16:creationId xmlns:a16="http://schemas.microsoft.com/office/drawing/2014/main" id="{0D634D66-D198-FB4A-9C62-7B703A253477}"/>
              </a:ext>
            </a:extLst>
          </p:cNvPr>
          <p:cNvSpPr/>
          <p:nvPr/>
        </p:nvSpPr>
        <p:spPr>
          <a:xfrm>
            <a:off x="4529003" y="566195"/>
            <a:ext cx="127470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1"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Repeats 2</a:t>
            </a:r>
            <a:endParaRPr lang="zh-CN" altLang="en-US" dirty="0"/>
          </a:p>
        </p:txBody>
      </p:sp>
      <p:sp>
        <p:nvSpPr>
          <p:cNvPr id="31" name="左大括号 30">
            <a:extLst>
              <a:ext uri="{FF2B5EF4-FFF2-40B4-BE49-F238E27FC236}">
                <a16:creationId xmlns:a16="http://schemas.microsoft.com/office/drawing/2014/main" id="{08B4080E-05AA-A044-B620-42CCC90D03B9}"/>
              </a:ext>
            </a:extLst>
          </p:cNvPr>
          <p:cNvSpPr/>
          <p:nvPr/>
        </p:nvSpPr>
        <p:spPr>
          <a:xfrm rot="5400000">
            <a:off x="7314238" y="42907"/>
            <a:ext cx="248924" cy="2084441"/>
          </a:xfrm>
          <a:prstGeom prst="leftBrace">
            <a:avLst/>
          </a:prstGeom>
          <a:ln w="317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zh-CN" altLang="en-US" dirty="0"/>
          </a:p>
        </p:txBody>
      </p:sp>
      <p:sp>
        <p:nvSpPr>
          <p:cNvPr id="32" name="矩形 31">
            <a:extLst>
              <a:ext uri="{FF2B5EF4-FFF2-40B4-BE49-F238E27FC236}">
                <a16:creationId xmlns:a16="http://schemas.microsoft.com/office/drawing/2014/main" id="{D064AD3E-7B84-0C4E-BE56-2A40A945E9A6}"/>
              </a:ext>
            </a:extLst>
          </p:cNvPr>
          <p:cNvSpPr/>
          <p:nvPr/>
        </p:nvSpPr>
        <p:spPr>
          <a:xfrm>
            <a:off x="6682430" y="566195"/>
            <a:ext cx="127470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1"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Repeats 3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9325760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82</TotalTime>
  <Words>163</Words>
  <Application>Microsoft Macintosh PowerPoint</Application>
  <PresentationFormat>宽屏</PresentationFormat>
  <Paragraphs>111</Paragraphs>
  <Slides>9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9</vt:i4>
      </vt:variant>
    </vt:vector>
  </HeadingPairs>
  <TitlesOfParts>
    <vt:vector size="13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Manager/>
  <Company/>
  <LinksUpToDate>false</LinksUpToDate>
  <SharedDoc>false</SharedDoc>
  <HyperlinkBase/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subject/>
  <dc:creator>16500</dc:creator>
  <cp:keywords/>
  <dc:description/>
  <cp:lastModifiedBy>JDu</cp:lastModifiedBy>
  <cp:revision>30</cp:revision>
  <dcterms:created xsi:type="dcterms:W3CDTF">2025-08-19T01:53:44Z</dcterms:created>
  <dcterms:modified xsi:type="dcterms:W3CDTF">2026-03-06T10:36:55Z</dcterms:modified>
  <cp:category/>
</cp:coreProperties>
</file>